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2" r:id="rId2"/>
  </p:sldIdLst>
  <p:sldSz cx="6858000" cy="9906000" type="A4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208" autoAdjust="0"/>
    <p:restoredTop sz="94660"/>
  </p:normalViewPr>
  <p:slideViewPr>
    <p:cSldViewPr snapToGrid="0">
      <p:cViewPr>
        <p:scale>
          <a:sx n="130" d="100"/>
          <a:sy n="130" d="100"/>
        </p:scale>
        <p:origin x="568" y="-1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37800-8E96-4C68-841B-69E739FA5B5B}" type="datetimeFigureOut">
              <a:rPr lang="es-ES" smtClean="0"/>
              <a:t>9/6/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302A7-FBB9-47FD-B8C6-D54F08F507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486238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37800-8E96-4C68-841B-69E739FA5B5B}" type="datetimeFigureOut">
              <a:rPr lang="es-ES" smtClean="0"/>
              <a:t>9/6/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302A7-FBB9-47FD-B8C6-D54F08F507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068019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37800-8E96-4C68-841B-69E739FA5B5B}" type="datetimeFigureOut">
              <a:rPr lang="es-ES" smtClean="0"/>
              <a:t>9/6/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302A7-FBB9-47FD-B8C6-D54F08F507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479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37800-8E96-4C68-841B-69E739FA5B5B}" type="datetimeFigureOut">
              <a:rPr lang="es-ES" smtClean="0"/>
              <a:t>9/6/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302A7-FBB9-47FD-B8C6-D54F08F507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8916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37800-8E96-4C68-841B-69E739FA5B5B}" type="datetimeFigureOut">
              <a:rPr lang="es-ES" smtClean="0"/>
              <a:t>9/6/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302A7-FBB9-47FD-B8C6-D54F08F507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702035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37800-8E96-4C68-841B-69E739FA5B5B}" type="datetimeFigureOut">
              <a:rPr lang="es-ES" smtClean="0"/>
              <a:t>9/6/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302A7-FBB9-47FD-B8C6-D54F08F507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612102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37800-8E96-4C68-841B-69E739FA5B5B}" type="datetimeFigureOut">
              <a:rPr lang="es-ES" smtClean="0"/>
              <a:t>9/6/19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302A7-FBB9-47FD-B8C6-D54F08F507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499530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37800-8E96-4C68-841B-69E739FA5B5B}" type="datetimeFigureOut">
              <a:rPr lang="es-ES" smtClean="0"/>
              <a:t>9/6/19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302A7-FBB9-47FD-B8C6-D54F08F507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853451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37800-8E96-4C68-841B-69E739FA5B5B}" type="datetimeFigureOut">
              <a:rPr lang="es-ES" smtClean="0"/>
              <a:t>9/6/19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302A7-FBB9-47FD-B8C6-D54F08F507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381656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37800-8E96-4C68-841B-69E739FA5B5B}" type="datetimeFigureOut">
              <a:rPr lang="es-ES" smtClean="0"/>
              <a:t>9/6/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302A7-FBB9-47FD-B8C6-D54F08F507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66376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37800-8E96-4C68-841B-69E739FA5B5B}" type="datetimeFigureOut">
              <a:rPr lang="es-ES" smtClean="0"/>
              <a:t>9/6/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302A7-FBB9-47FD-B8C6-D54F08F507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821117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037800-8E96-4C68-841B-69E739FA5B5B}" type="datetimeFigureOut">
              <a:rPr lang="es-ES" smtClean="0"/>
              <a:t>9/6/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6302A7-FBB9-47FD-B8C6-D54F08F507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703718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/>
          <p:cNvPicPr>
            <a:picLocks noChangeAspect="1"/>
          </p:cNvPicPr>
          <p:nvPr/>
        </p:nvPicPr>
        <p:blipFill rotWithShape="1">
          <a:blip r:embed="rId2"/>
          <a:srcRect l="11413" r="35272" b="21491"/>
          <a:stretch/>
        </p:blipFill>
        <p:spPr>
          <a:xfrm>
            <a:off x="278296" y="880243"/>
            <a:ext cx="6500192" cy="2260522"/>
          </a:xfrm>
          <a:prstGeom prst="rect">
            <a:avLst/>
          </a:prstGeom>
        </p:spPr>
      </p:pic>
      <p:sp>
        <p:nvSpPr>
          <p:cNvPr id="6" name="Rectángulo 5"/>
          <p:cNvSpPr/>
          <p:nvPr/>
        </p:nvSpPr>
        <p:spPr>
          <a:xfrm>
            <a:off x="457201" y="3498444"/>
            <a:ext cx="6142382" cy="53687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9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. PBMC lymphocytes and monocytes populations. Representative images. </a:t>
            </a:r>
            <a:r>
              <a:rPr lang="en-US" sz="9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amples were analyzed focusing on lymphocyte and monocyte populations in the SSC vs. FSC plots, gating on single cells and negative for </a:t>
            </a:r>
            <a:r>
              <a:rPr lang="en-US" sz="9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nexin</a:t>
            </a:r>
            <a:r>
              <a:rPr lang="en-US" sz="9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V in APC-Cy7  </a:t>
            </a:r>
            <a:endParaRPr lang="es-EC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12148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08</TotalTime>
  <Words>41</Words>
  <Application>Microsoft Macintosh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s Bernardo Caicedo Paliz</dc:creator>
  <cp:lastModifiedBy>Microsoft Office User</cp:lastModifiedBy>
  <cp:revision>70</cp:revision>
  <dcterms:created xsi:type="dcterms:W3CDTF">2018-07-23T21:50:29Z</dcterms:created>
  <dcterms:modified xsi:type="dcterms:W3CDTF">2019-06-10T01:21:19Z</dcterms:modified>
</cp:coreProperties>
</file>